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22" r:id="rId2"/>
    <p:sldId id="323" r:id="rId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oleObject" Target="../embeddings/oleObject12.bin"/><Relationship Id="rId18" Type="http://schemas.openxmlformats.org/officeDocument/2006/relationships/image" Target="../media/image14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1.emf"/><Relationship Id="rId17" Type="http://schemas.openxmlformats.org/officeDocument/2006/relationships/oleObject" Target="../embeddings/oleObject14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3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5" Type="http://schemas.openxmlformats.org/officeDocument/2006/relationships/oleObject" Target="../embeddings/oleObject13.bin"/><Relationship Id="rId10" Type="http://schemas.openxmlformats.org/officeDocument/2006/relationships/image" Target="../media/image10.emf"/><Relationship Id="rId4" Type="http://schemas.openxmlformats.org/officeDocument/2006/relationships/image" Target="../media/image7.e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4640578"/>
              </p:ext>
            </p:extLst>
          </p:nvPr>
        </p:nvGraphicFramePr>
        <p:xfrm>
          <a:off x="8377150" y="662882"/>
          <a:ext cx="3423786" cy="2235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4" r:id="rId3" imgW="4248000" imgH="3162240" progId="">
                  <p:embed/>
                </p:oleObj>
              </mc:Choice>
              <mc:Fallback>
                <p:oleObj r:id="rId3" imgW="4248000" imgH="3162240" progId="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377150" y="662882"/>
                        <a:ext cx="3423786" cy="223559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3218188"/>
              </p:ext>
            </p:extLst>
          </p:nvPr>
        </p:nvGraphicFramePr>
        <p:xfrm>
          <a:off x="4362945" y="662883"/>
          <a:ext cx="3694127" cy="22355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5" r:id="rId5" imgW="4248000" imgH="3144600" progId="">
                  <p:embed/>
                </p:oleObj>
              </mc:Choice>
              <mc:Fallback>
                <p:oleObj r:id="rId5" imgW="4248000" imgH="3144600" progId="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62945" y="662883"/>
                        <a:ext cx="3694127" cy="223559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8458365"/>
              </p:ext>
            </p:extLst>
          </p:nvPr>
        </p:nvGraphicFramePr>
        <p:xfrm>
          <a:off x="343034" y="666211"/>
          <a:ext cx="3694127" cy="22317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6" r:id="rId7" imgW="4605840" imgH="3233880" progId="">
                  <p:embed/>
                </p:oleObj>
              </mc:Choice>
              <mc:Fallback>
                <p:oleObj r:id="rId7" imgW="4605840" imgH="3233880" progId="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3034" y="666211"/>
                        <a:ext cx="3694127" cy="223172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4118022"/>
              </p:ext>
            </p:extLst>
          </p:nvPr>
        </p:nvGraphicFramePr>
        <p:xfrm>
          <a:off x="343035" y="3388829"/>
          <a:ext cx="3694126" cy="2287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7" r:id="rId9" imgW="4605840" imgH="3233880" progId="">
                  <p:embed/>
                </p:oleObj>
              </mc:Choice>
              <mc:Fallback>
                <p:oleObj r:id="rId9" imgW="4605840" imgH="3233880" progId="">
                  <p:embed/>
                  <p:pic>
                    <p:nvPicPr>
                      <p:cNvPr id="0" name="Objec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3035" y="3388829"/>
                        <a:ext cx="3694126" cy="22873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5386703"/>
              </p:ext>
            </p:extLst>
          </p:nvPr>
        </p:nvGraphicFramePr>
        <p:xfrm>
          <a:off x="4315499" y="3388829"/>
          <a:ext cx="3771766" cy="2287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8" r:id="rId11" imgW="4248000" imgH="3126600" progId="">
                  <p:embed/>
                </p:oleObj>
              </mc:Choice>
              <mc:Fallback>
                <p:oleObj r:id="rId11" imgW="4248000" imgH="3126600" progId="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15499" y="3388829"/>
                        <a:ext cx="3771766" cy="22873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2672380"/>
              </p:ext>
            </p:extLst>
          </p:nvPr>
        </p:nvGraphicFramePr>
        <p:xfrm>
          <a:off x="8377150" y="3388829"/>
          <a:ext cx="3423786" cy="2287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9" r:id="rId13" imgW="4248000" imgH="3162240" progId="">
                  <p:embed/>
                </p:oleObj>
              </mc:Choice>
              <mc:Fallback>
                <p:oleObj r:id="rId13" imgW="4248000" imgH="3162240" progId="">
                  <p:embed/>
                  <p:pic>
                    <p:nvPicPr>
                      <p:cNvPr id="0" name="Object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377150" y="3388829"/>
                        <a:ext cx="3423786" cy="22873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95771" y="50572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</a:p>
        </p:txBody>
      </p:sp>
    </p:spTree>
    <p:extLst>
      <p:ext uri="{BB962C8B-B14F-4D97-AF65-F5344CB8AC3E}">
        <p14:creationId xmlns:p14="http://schemas.microsoft.com/office/powerpoint/2010/main" val="42936567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1518045"/>
              </p:ext>
            </p:extLst>
          </p:nvPr>
        </p:nvGraphicFramePr>
        <p:xfrm>
          <a:off x="4357240" y="84697"/>
          <a:ext cx="3561809" cy="20719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4" r:id="rId3" imgW="4740120" imgH="3233880" progId="">
                  <p:embed/>
                </p:oleObj>
              </mc:Choice>
              <mc:Fallback>
                <p:oleObj r:id="rId3" imgW="4740120" imgH="3233880" progId="">
                  <p:embed/>
                  <p:pic>
                    <p:nvPicPr>
                      <p:cNvPr id="9" name="Objec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57240" y="84697"/>
                        <a:ext cx="3561809" cy="207190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698710"/>
              </p:ext>
            </p:extLst>
          </p:nvPr>
        </p:nvGraphicFramePr>
        <p:xfrm>
          <a:off x="389087" y="84696"/>
          <a:ext cx="3691207" cy="20719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5" r:id="rId5" imgW="4382280" imgH="3162240" progId="">
                  <p:embed/>
                </p:oleObj>
              </mc:Choice>
              <mc:Fallback>
                <p:oleObj r:id="rId5" imgW="4382280" imgH="3162240" progId="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9087" y="84696"/>
                        <a:ext cx="3691207" cy="207190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9882520"/>
              </p:ext>
            </p:extLst>
          </p:nvPr>
        </p:nvGraphicFramePr>
        <p:xfrm>
          <a:off x="8195995" y="84697"/>
          <a:ext cx="3561809" cy="20719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6" r:id="rId7" imgW="4364280" imgH="3180240" progId="">
                  <p:embed/>
                </p:oleObj>
              </mc:Choice>
              <mc:Fallback>
                <p:oleObj r:id="rId7" imgW="4364280" imgH="3180240" progId="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95995" y="84697"/>
                        <a:ext cx="3561809" cy="207190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4816189"/>
              </p:ext>
            </p:extLst>
          </p:nvPr>
        </p:nvGraphicFramePr>
        <p:xfrm>
          <a:off x="389087" y="2285635"/>
          <a:ext cx="3691207" cy="22001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7" r:id="rId9" imgW="4740120" imgH="3233880" progId="">
                  <p:embed/>
                </p:oleObj>
              </mc:Choice>
              <mc:Fallback>
                <p:oleObj r:id="rId9" imgW="4740120" imgH="3233880" progId="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9087" y="2285635"/>
                        <a:ext cx="3691207" cy="220010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7964752"/>
              </p:ext>
            </p:extLst>
          </p:nvPr>
        </p:nvGraphicFramePr>
        <p:xfrm>
          <a:off x="4357239" y="2285635"/>
          <a:ext cx="3561809" cy="22001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8" r:id="rId11" imgW="4740120" imgH="3233880" progId="">
                  <p:embed/>
                </p:oleObj>
              </mc:Choice>
              <mc:Fallback>
                <p:oleObj r:id="rId11" imgW="4740120" imgH="3233880" progId="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57239" y="2285635"/>
                        <a:ext cx="3561809" cy="220010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338287"/>
              </p:ext>
            </p:extLst>
          </p:nvPr>
        </p:nvGraphicFramePr>
        <p:xfrm>
          <a:off x="8195995" y="2285635"/>
          <a:ext cx="3561809" cy="22001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9" r:id="rId13" imgW="4364280" imgH="3117600" progId="">
                  <p:embed/>
                </p:oleObj>
              </mc:Choice>
              <mc:Fallback>
                <p:oleObj r:id="rId13" imgW="4364280" imgH="3117600" progId="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95995" y="2285635"/>
                        <a:ext cx="3561809" cy="220010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0762327"/>
              </p:ext>
            </p:extLst>
          </p:nvPr>
        </p:nvGraphicFramePr>
        <p:xfrm>
          <a:off x="380458" y="4570736"/>
          <a:ext cx="3691207" cy="22182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0" r:id="rId15" imgW="4740120" imgH="3233880" progId="">
                  <p:embed/>
                </p:oleObj>
              </mc:Choice>
              <mc:Fallback>
                <p:oleObj r:id="rId15" imgW="4740120" imgH="3233880" progId="">
                  <p:embed/>
                  <p:pic>
                    <p:nvPicPr>
                      <p:cNvPr id="0" name="Object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0458" y="4570736"/>
                        <a:ext cx="3691207" cy="221825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1495373"/>
              </p:ext>
            </p:extLst>
          </p:nvPr>
        </p:nvGraphicFramePr>
        <p:xfrm>
          <a:off x="4357239" y="4570736"/>
          <a:ext cx="3561809" cy="21872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1" r:id="rId17" imgW="4364280" imgH="3162240" progId="">
                  <p:embed/>
                </p:oleObj>
              </mc:Choice>
              <mc:Fallback>
                <p:oleObj r:id="rId17" imgW="4364280" imgH="3162240" progId="">
                  <p:embed/>
                  <p:pic>
                    <p:nvPicPr>
                      <p:cNvPr id="0" name="Object 3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57239" y="4570736"/>
                        <a:ext cx="3561809" cy="218724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8288625" y="4918276"/>
            <a:ext cx="373157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6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Dose-dependent effect of ACY-1215 and tubastatin-A on the biochemical activity of the HDACs and SIRTs</a:t>
            </a:r>
            <a:endParaRPr lang="en-US" sz="1200"/>
          </a:p>
        </p:txBody>
      </p:sp>
    </p:spTree>
    <p:extLst>
      <p:ext uri="{BB962C8B-B14F-4D97-AF65-F5344CB8AC3E}">
        <p14:creationId xmlns:p14="http://schemas.microsoft.com/office/powerpoint/2010/main" val="2441644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22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03:12Z</dcterms:modified>
</cp:coreProperties>
</file>